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02" r:id="rId2"/>
    <p:sldId id="303" r:id="rId3"/>
    <p:sldId id="304" r:id="rId4"/>
    <p:sldId id="305" r:id="rId5"/>
    <p:sldId id="306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038"/>
    <p:restoredTop sz="94729"/>
  </p:normalViewPr>
  <p:slideViewPr>
    <p:cSldViewPr snapToGrid="0">
      <p:cViewPr varScale="1">
        <p:scale>
          <a:sx n="67" d="100"/>
          <a:sy n="67" d="100"/>
        </p:scale>
        <p:origin x="340" y="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117D75-71E9-1E75-0649-CB35193906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B3AAF66-BCD3-A57A-A040-CE7E893E29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044A6F-325A-7D33-9C2D-0E1E3401D3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F5A49-0E5C-4B4A-9F4D-287773B3F35E}" type="datetimeFigureOut">
              <a:rPr kumimoji="1" lang="ja-JP" altLang="en-US" smtClean="0"/>
              <a:pPr/>
              <a:t>2026/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44826F5-0EEB-EBF2-2573-2142C62A0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6A94BDB-3322-1B6D-DEEB-5828CCC628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AD959-DF4E-2A42-9467-E75B7B49468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199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D2B8EC-E185-D074-B20A-29268FB58F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B131024-F1FC-50C0-43A0-A748BF516D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6B923E3-146B-BA37-2796-1FEFEDCDB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F5A49-0E5C-4B4A-9F4D-287773B3F35E}" type="datetimeFigureOut">
              <a:rPr kumimoji="1" lang="ja-JP" altLang="en-US" smtClean="0"/>
              <a:pPr/>
              <a:t>2026/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D43551C-D3F5-64D2-B76E-C4DFB74B2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AFF6BE-408B-7833-B375-B07C67DFF3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AD959-DF4E-2A42-9467-E75B7B49468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7131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FB23A12-FD3F-2D8D-C220-398AE288FB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EAC7BDA-82B2-35F3-58B9-519C4CF9A8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80DB6EF-C8A0-5517-C5DA-5CCD03E6B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F5A49-0E5C-4B4A-9F4D-287773B3F35E}" type="datetimeFigureOut">
              <a:rPr kumimoji="1" lang="ja-JP" altLang="en-US" smtClean="0"/>
              <a:pPr/>
              <a:t>2026/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6B3CA1-E386-3D63-2FF1-A6745D701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62860C0-6436-295D-AB75-7F56720DB0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AD959-DF4E-2A42-9467-E75B7B49468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3956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C8E3AB-9DFF-FEE2-8AF2-B97AC64556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A3CA3F0-0EF4-7488-7575-36EBA7B31F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42DDD5-BEF5-20A1-F78E-A08C3BE5A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F5A49-0E5C-4B4A-9F4D-287773B3F35E}" type="datetimeFigureOut">
              <a:rPr kumimoji="1" lang="ja-JP" altLang="en-US" smtClean="0"/>
              <a:pPr/>
              <a:t>2026/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D756CB8-BD45-F543-196C-EBA80CE1BF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B2BDED-084E-39A7-7314-45FF696AA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AD959-DF4E-2A42-9467-E75B7B49468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652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12126E0-B907-3192-9433-CEF47C432F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E1C6824-490D-7333-BC3D-453054205D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45E774-5D7E-2671-6240-7472D5CEC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F5A49-0E5C-4B4A-9F4D-287773B3F35E}" type="datetimeFigureOut">
              <a:rPr kumimoji="1" lang="ja-JP" altLang="en-US" smtClean="0"/>
              <a:pPr/>
              <a:t>2026/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45A0902-04C8-90FC-C917-DA4D99AB1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D1ED61B-1E94-490F-243F-B0F30D47F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AD959-DF4E-2A42-9467-E75B7B49468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88828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7554A1-497E-5E79-82BC-E3EDC96B7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73FF410-FAA8-57A0-CB95-9003E9FAD1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814B665-AF9C-4BED-745D-340824A5F6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B373562-0E5E-FB35-B7BC-8BA19DF8A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F5A49-0E5C-4B4A-9F4D-287773B3F35E}" type="datetimeFigureOut">
              <a:rPr kumimoji="1" lang="ja-JP" altLang="en-US" smtClean="0"/>
              <a:pPr/>
              <a:t>2026/2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029863B-3E28-7C80-39A2-4101EA746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F0943CC-567C-18DB-46D6-1900930CBD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AD959-DF4E-2A42-9467-E75B7B49468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3902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096D483-E3F9-0915-A5E8-5D62D2CA55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78A5A70-9AAA-BBAF-58DE-487D49577C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B2F259E-669C-E87B-2695-B387494750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6F8F073-8430-54C2-97D2-13A8E90C62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3B6E539-B22A-2A3A-17B5-F0E6547AA6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8C379BB-91FF-0A6A-3450-49FA0AAEE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F5A49-0E5C-4B4A-9F4D-287773B3F35E}" type="datetimeFigureOut">
              <a:rPr kumimoji="1" lang="ja-JP" altLang="en-US" smtClean="0"/>
              <a:pPr/>
              <a:t>2026/2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D676AF9-1C1D-3012-21E6-F49A008D1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5A395DC-FE60-924A-568A-AC970A0E10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AD959-DF4E-2A42-9467-E75B7B49468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0005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C0EF06-7BAD-0C75-A717-AAE1E82C04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3F42E7D-D7EE-A5B6-F7FC-43E9B0C6B9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F5A49-0E5C-4B4A-9F4D-287773B3F35E}" type="datetimeFigureOut">
              <a:rPr kumimoji="1" lang="ja-JP" altLang="en-US" smtClean="0"/>
              <a:pPr/>
              <a:t>2026/2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1EFAFE8-82A6-AF1B-5D96-1EA345DA4C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CA16953-3C1D-35C3-5546-CBC6987E0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AD959-DF4E-2A42-9467-E75B7B49468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2184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2C19289-A8CB-E958-681F-4E29F21E8B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F5A49-0E5C-4B4A-9F4D-287773B3F35E}" type="datetimeFigureOut">
              <a:rPr kumimoji="1" lang="ja-JP" altLang="en-US" smtClean="0"/>
              <a:pPr/>
              <a:t>2026/2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C2E0D4F-0EC8-3DD2-9F9F-1FA8072E4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13A167D-E56E-11E6-B72E-0CCA706961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AD959-DF4E-2A42-9467-E75B7B49468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2052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0342FD-C53C-56BF-CA98-597CFA1FEA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B05B3A4-AC02-F686-9781-A72E174BDE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0558CCA-2677-9D8D-16B1-1FEE43ECEE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E50B79B-B653-C62D-1AA5-201A8EDC2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F5A49-0E5C-4B4A-9F4D-287773B3F35E}" type="datetimeFigureOut">
              <a:rPr kumimoji="1" lang="ja-JP" altLang="en-US" smtClean="0"/>
              <a:pPr/>
              <a:t>2026/2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24721E8-6C6C-09B0-4A03-E198D0EF3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AC311E5-B748-3597-37AE-3A2C7AB37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AD959-DF4E-2A42-9467-E75B7B49468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1935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C99370-163E-0D81-43A2-CD9655BA51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0C3EBD8-0077-6477-3CAF-60E4A5506C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D1E8E1E-4A9C-1A8B-79B0-6B2682F3A5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32AF97E-FC29-E811-DDEC-80C692A12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F5A49-0E5C-4B4A-9F4D-287773B3F35E}" type="datetimeFigureOut">
              <a:rPr kumimoji="1" lang="ja-JP" altLang="en-US" smtClean="0"/>
              <a:pPr/>
              <a:t>2026/2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3969005-F245-793A-60D2-58624996B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8C116B6-1F58-256C-399B-891338CAD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AD959-DF4E-2A42-9467-E75B7B49468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856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03921A1-3A51-51B9-6E28-A38959FF7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2C9EB96-C4AF-EC76-ECEE-16B208B990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175D958-39EC-A674-4A85-47509A6DBF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AF5A49-0E5C-4B4A-9F4D-287773B3F35E}" type="datetimeFigureOut">
              <a:rPr kumimoji="1" lang="ja-JP" altLang="en-US" smtClean="0"/>
              <a:pPr/>
              <a:t>2026/2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0702DC9-8B4F-44E1-C3AE-A0E15EAE6B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994064A-44A6-FEA0-16BA-F89689EE08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0EAD959-DF4E-2A42-9467-E75B7B49468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0661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BB4FD5E-1E65-15CF-2ED1-1655225B9B9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63C87FF-2C70-7D9E-D770-5A7964C423E7}"/>
              </a:ext>
            </a:extLst>
          </p:cNvPr>
          <p:cNvSpPr txBox="1"/>
          <p:nvPr/>
        </p:nvSpPr>
        <p:spPr>
          <a:xfrm>
            <a:off x="84667" y="66270"/>
            <a:ext cx="914399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. Flowchart</a:t>
            </a:r>
            <a:endParaRPr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コンテンツ プレースホルダー 2">
            <a:extLst>
              <a:ext uri="{FF2B5EF4-FFF2-40B4-BE49-F238E27FC236}">
                <a16:creationId xmlns:a16="http://schemas.microsoft.com/office/drawing/2014/main" id="{E39E3E88-63EE-D684-566D-8BE4E032B7E9}"/>
              </a:ext>
            </a:extLst>
          </p:cNvPr>
          <p:cNvSpPr txBox="1">
            <a:spLocks/>
          </p:cNvSpPr>
          <p:nvPr/>
        </p:nvSpPr>
        <p:spPr>
          <a:xfrm>
            <a:off x="304800" y="5370767"/>
            <a:ext cx="5570706" cy="523920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vert="horz" lIns="91440" tIns="45720" rIns="91440" bIns="45720" rtlCol="0" anchor="ctr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zed in the current study (n=1,069,948)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コンテンツ プレースホルダー 2">
            <a:extLst>
              <a:ext uri="{FF2B5EF4-FFF2-40B4-BE49-F238E27FC236}">
                <a16:creationId xmlns:a16="http://schemas.microsoft.com/office/drawing/2014/main" id="{BB65C290-93A5-8A4B-3C5F-3A3E14CD654B}"/>
              </a:ext>
            </a:extLst>
          </p:cNvPr>
          <p:cNvSpPr txBox="1">
            <a:spLocks/>
          </p:cNvSpPr>
          <p:nvPr/>
        </p:nvSpPr>
        <p:spPr>
          <a:xfrm>
            <a:off x="1685399" y="1823764"/>
            <a:ext cx="10201796" cy="1605236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ja-JP" altLang="en-US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・</a:t>
            </a:r>
            <a:r>
              <a:rPr lang="en-US" altLang="ja-JP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ior d</a:t>
            </a:r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agnosis of hypertension</a:t>
            </a:r>
            <a:r>
              <a:rPr lang="en-US" altLang="ja-JP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n=1,298,887)</a:t>
            </a: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ja-JP" altLang="en-US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・</a:t>
            </a:r>
            <a:r>
              <a:rPr lang="en-US" altLang="ja-JP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escri</a:t>
            </a:r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tion for antihypertensive drugs within 6 months before baseline </a:t>
            </a:r>
            <a:r>
              <a:rPr lang="en-US" altLang="ja-JP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n=</a:t>
            </a:r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8,194</a:t>
            </a:r>
            <a:r>
              <a:rPr lang="en-US" altLang="ja-JP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</a:t>
            </a: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ja-JP" altLang="en-US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・</a:t>
            </a:r>
            <a:r>
              <a:rPr lang="en-US" altLang="ja-JP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igh blood pressure (</a:t>
            </a:r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BP </a:t>
            </a:r>
            <a:r>
              <a:rPr lang="ja-JP" alt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≥ </a:t>
            </a:r>
            <a:r>
              <a:rPr lang="en-US" altLang="ja-JP" sz="200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40mmHg and/or </a:t>
            </a:r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BP </a:t>
            </a:r>
            <a:r>
              <a:rPr lang="ja-JP" altLang="en-US" sz="2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≥ </a:t>
            </a:r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90mmHg</a:t>
            </a:r>
            <a:r>
              <a:rPr lang="en-US" altLang="ja-JP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 at baseline </a:t>
            </a:r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ealth check-up</a:t>
            </a:r>
            <a:r>
              <a:rPr lang="en-US" altLang="ja-JP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n=361,623)</a:t>
            </a: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ja-JP" altLang="en-US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・</a:t>
            </a:r>
            <a:r>
              <a:rPr lang="en-US" altLang="ja-JP" sz="2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ollow-up period of  0 days</a:t>
            </a:r>
            <a:r>
              <a:rPr lang="en-US" altLang="ja-JP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n=3,008)</a:t>
            </a:r>
            <a:endParaRPr lang="ja-JP" altLang="ja-JP" sz="20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0" name="コンテンツ プレースホルダー 2">
            <a:extLst>
              <a:ext uri="{FF2B5EF4-FFF2-40B4-BE49-F238E27FC236}">
                <a16:creationId xmlns:a16="http://schemas.microsoft.com/office/drawing/2014/main" id="{391E3E95-77B5-D35B-01B6-D7C66FC3DD81}"/>
              </a:ext>
            </a:extLst>
          </p:cNvPr>
          <p:cNvSpPr txBox="1">
            <a:spLocks/>
          </p:cNvSpPr>
          <p:nvPr/>
        </p:nvSpPr>
        <p:spPr>
          <a:xfrm>
            <a:off x="1685399" y="3573963"/>
            <a:ext cx="10201790" cy="162453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ssing data on 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garette smoking (n=101,141)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cohol consumption (n=145,301)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sical activity (n=173,584)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ja-JP" altLang="en-US" sz="2000"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eep quality(n=9,495)</a:t>
            </a:r>
          </a:p>
          <a:p>
            <a:pPr marL="0" indent="0">
              <a:lnSpc>
                <a:spcPct val="100000"/>
              </a:lnSpc>
              <a:spcBef>
                <a:spcPts val="0"/>
              </a:spcBef>
              <a:buNone/>
            </a:pPr>
            <a:endParaRPr lang="en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AB0464B8-A771-EB07-672B-0E523A32F2DA}"/>
              </a:ext>
            </a:extLst>
          </p:cNvPr>
          <p:cNvCxnSpPr>
            <a:cxnSpLocks/>
          </p:cNvCxnSpPr>
          <p:nvPr/>
        </p:nvCxnSpPr>
        <p:spPr>
          <a:xfrm flipH="1">
            <a:off x="1239951" y="1606892"/>
            <a:ext cx="1" cy="3763875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2E4706A6-5D2C-0B92-5A69-732D0CE160B4}"/>
              </a:ext>
            </a:extLst>
          </p:cNvPr>
          <p:cNvCxnSpPr>
            <a:cxnSpLocks/>
          </p:cNvCxnSpPr>
          <p:nvPr/>
        </p:nvCxnSpPr>
        <p:spPr>
          <a:xfrm>
            <a:off x="1239951" y="2634746"/>
            <a:ext cx="445448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EC535B72-DAE3-3C38-795F-2254C79F4253}"/>
              </a:ext>
            </a:extLst>
          </p:cNvPr>
          <p:cNvCxnSpPr>
            <a:cxnSpLocks/>
          </p:cNvCxnSpPr>
          <p:nvPr/>
        </p:nvCxnSpPr>
        <p:spPr>
          <a:xfrm>
            <a:off x="1239952" y="4355124"/>
            <a:ext cx="445448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コンテンツ プレースホルダー 2">
            <a:extLst>
              <a:ext uri="{FF2B5EF4-FFF2-40B4-BE49-F238E27FC236}">
                <a16:creationId xmlns:a16="http://schemas.microsoft.com/office/drawing/2014/main" id="{C5679864-E503-3789-96AA-97248DF65371}"/>
              </a:ext>
            </a:extLst>
          </p:cNvPr>
          <p:cNvSpPr txBox="1">
            <a:spLocks/>
          </p:cNvSpPr>
          <p:nvPr/>
        </p:nvSpPr>
        <p:spPr>
          <a:xfrm>
            <a:off x="304801" y="886671"/>
            <a:ext cx="11582400" cy="720222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vert="horz" lIns="91440" tIns="45720" rIns="91440" bIns="45720" rtlCol="0" anchor="ctr"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viduals with available data on health checkups in the </a:t>
            </a:r>
            <a:r>
              <a:rPr kumimoji="1" lang="en-US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SC</a:t>
            </a:r>
            <a:r>
              <a:rPr lang="en-US" altLang="ja-JP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atabase</a:t>
            </a:r>
            <a:r>
              <a:rPr lang="en-US" altLang="ja-JP" sz="20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 </a:t>
            </a:r>
          </a:p>
          <a:p>
            <a:pPr marL="0" indent="0">
              <a:buNone/>
            </a:pP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3,221,181)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50772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C686C8BB-5875-A0C6-0803-1B59B13A27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57845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グラフ, 折れ線グラフ, 箱ひげ図&#10;&#10;AI 生成コンテンツは誤りを含む可能性があります。">
            <a:extLst>
              <a:ext uri="{FF2B5EF4-FFF2-40B4-BE49-F238E27FC236}">
                <a16:creationId xmlns:a16="http://schemas.microsoft.com/office/drawing/2014/main" id="{27B2B8F7-91F8-7529-EBA4-F3A9F5CAE3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8789" y="0"/>
            <a:ext cx="979714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90924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グラフ, 箱ひげ図&#10;&#10;AI 生成コンテンツは誤りを含む可能性があります。">
            <a:extLst>
              <a:ext uri="{FF2B5EF4-FFF2-40B4-BE49-F238E27FC236}">
                <a16:creationId xmlns:a16="http://schemas.microsoft.com/office/drawing/2014/main" id="{93E5B8BD-C828-2F41-E725-996DAA7284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9749" y="0"/>
            <a:ext cx="979714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8511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ACF635A-74F5-ED61-6921-DD1B0E4F9EB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F456D7BF-0F22-5FCB-1F75-E5A4968F58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3503" y="0"/>
            <a:ext cx="979714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4967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82</TotalTime>
  <Words>125</Words>
  <Application>Microsoft Office PowerPoint</Application>
  <PresentationFormat>ワイド画面</PresentationFormat>
  <Paragraphs>13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sachikanishikawa@gmail.com</dc:creator>
  <cp:lastModifiedBy>米丘友架</cp:lastModifiedBy>
  <cp:revision>15</cp:revision>
  <dcterms:created xsi:type="dcterms:W3CDTF">2025-07-12T11:43:59Z</dcterms:created>
  <dcterms:modified xsi:type="dcterms:W3CDTF">2026-02-02T17:01:13Z</dcterms:modified>
</cp:coreProperties>
</file>